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4"/>
    <p:restoredTop sz="94629"/>
  </p:normalViewPr>
  <p:slideViewPr>
    <p:cSldViewPr snapToGrid="0">
      <p:cViewPr varScale="1">
        <p:scale>
          <a:sx n="85" d="100"/>
          <a:sy n="85" d="100"/>
        </p:scale>
        <p:origin x="19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8C49B-D786-B0B7-2CA0-C3E119F8CA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71009D-3C64-B092-E428-E049B24C49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1A232A-263D-84C0-CF6F-0F0E1BFB9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DF3111-DF2B-7062-DA94-574A7ED8F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60FBE-DC51-1E08-5F5C-9C4048EB4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342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15A0F-0A14-DF76-3D96-ABB9B2BD7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3D7A95-9393-94B6-8055-4AE8BCEAED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C4674F-904D-C49A-1B6B-2B35EA43B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160D9E-5EF3-65A1-03C9-D759B7910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80B9D4-4127-1281-0CD9-5A3805557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989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0376E9-6BF7-01D7-4C89-2B30356C9A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E7D755-C76E-903E-E9EA-3722F878E6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EB38C-314A-830D-2737-E7F3988C9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8E69C-ED82-9948-AE0E-150F41B60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12C438-E1D6-12B2-B7A9-2084083F1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835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F85853-8034-E388-5E67-B947FAF65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3D357D-72CF-8258-20D9-AFDF317ED5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7263A-8733-1A02-95E0-EB0E67E25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C6E599-E9A8-716E-71DA-7B9F46ACA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0EE8B-D27A-FD03-D644-E5D55F636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17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727C2-D74E-7900-A4E1-FA7F39ABF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CD52C7-48BF-31EF-ACF8-4B3DD6D9E2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96CB5F-315F-1E10-8039-49F003852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C86A4D-03D1-2EE7-95E6-A169AFA3F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590E25-BB37-F8FF-D484-F2446243D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354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D77EED-59DC-E31A-EA10-008211CAA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904481-8FEA-5BD7-F8A1-AB30807552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967AA2-477C-EB6E-3E14-6C0375C6DC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D63C5B-E139-1217-0D90-DF73092A6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6670DA-9526-3DDF-A097-178A3E819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A6D624-902F-B3DD-B9CB-B89CAFB72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620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94BC9-B28D-F928-838A-346DC40D4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E4A534-C856-ACD0-DB3E-B14AC30B54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99F45F-288B-08D5-F057-977208CF7C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612551-1456-8D84-4EC3-0F35B56DD3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40C2F7-0248-49F4-8E4F-77DC99C0D8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43D949-F04B-BE65-D467-9FB292D09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281076-7B20-512E-9FF3-84C110007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2B810F-0BA9-90C3-0CC9-FD1FE970D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725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38385-A9B8-B86B-1EBD-71638FD9E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998C59-4DA1-9359-66EC-6A6401527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B60025-097C-F198-5452-F6D860D94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2D636-8139-5E6C-79D1-917415D59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876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327058-FA2E-F30F-15C4-3BE8AEBBD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304D61-C93F-1BF0-F130-C27C2D345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CCC704-28B3-35F8-EE6C-C01390999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927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24765-3755-1869-2E68-5CBADD593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025723-6DE8-B53D-1DD8-1B7D30429E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B733DC-9D2E-B7AC-82C1-87F2594B0C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6E7DCF-E7C0-8063-6DA4-346E15F6A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BE8913-6A88-9ABC-591B-277C580AC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58F491-DEAA-A6E4-D2A2-E26242386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625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699EA-7739-45EB-8AC6-A404544BDD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B69E0C-1E94-5292-6483-8B1DCFB226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B4FE6D-2A4F-93F9-FA62-8007F8AACD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2D0607-3D03-9C64-E22E-5FCC96B10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ECC987-6ADA-F161-2020-15E22D186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941036-83A3-6E61-5789-2A6B0FBA7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43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8B10D1-5AA2-1041-4A01-A89A5447D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288527-5C53-A6D6-7DAF-7E594AAAEC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1D6CD8-2531-39C7-E7D5-FBF36322AF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039371-F142-454C-8AE9-A73DB7412A06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A24DF4-9914-8892-9443-254B061A00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A5EBA-2630-1D8E-D332-9205D91B23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4B1759-0A9C-C441-83AE-6BF1284A7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25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microsoft.com/office/2007/relationships/hdphoto" Target="../media/hdphoto1.wdp"/><Relationship Id="rId7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emf"/><Relationship Id="rId10" Type="http://schemas.openxmlformats.org/officeDocument/2006/relationships/image" Target="../media/image8.emf"/><Relationship Id="rId4" Type="http://schemas.openxmlformats.org/officeDocument/2006/relationships/image" Target="../media/image4.png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8F08018-B716-9D7D-380B-C9B5DA28B1A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473"/>
          <a:stretch/>
        </p:blipFill>
        <p:spPr>
          <a:xfrm>
            <a:off x="2911688" y="926099"/>
            <a:ext cx="2647284" cy="25029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A04FE22-535E-EF6A-8D03-35DCF6D5CFF4}"/>
              </a:ext>
            </a:extLst>
          </p:cNvPr>
          <p:cNvSpPr txBox="1"/>
          <p:nvPr/>
        </p:nvSpPr>
        <p:spPr>
          <a:xfrm>
            <a:off x="90904" y="799584"/>
            <a:ext cx="632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1DBDAB-A509-B53B-9879-F5D0077AE366}"/>
              </a:ext>
            </a:extLst>
          </p:cNvPr>
          <p:cNvSpPr txBox="1"/>
          <p:nvPr/>
        </p:nvSpPr>
        <p:spPr>
          <a:xfrm>
            <a:off x="3773715" y="741433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MEM16F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80E2B41-B16C-CB29-21BF-1D151BFA81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098"/>
          <a:stretch/>
        </p:blipFill>
        <p:spPr>
          <a:xfrm>
            <a:off x="316472" y="1042401"/>
            <a:ext cx="2647284" cy="23865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266B875-C111-3AAB-38BC-0481C45D05EB}"/>
              </a:ext>
            </a:extLst>
          </p:cNvPr>
          <p:cNvSpPr txBox="1"/>
          <p:nvPr/>
        </p:nvSpPr>
        <p:spPr>
          <a:xfrm>
            <a:off x="783380" y="741433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kr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51A359-001A-F2BE-AC65-52220FBE6018}"/>
              </a:ext>
            </a:extLst>
          </p:cNvPr>
          <p:cNvSpPr txBox="1"/>
          <p:nvPr/>
        </p:nvSpPr>
        <p:spPr>
          <a:xfrm>
            <a:off x="2792627" y="766146"/>
            <a:ext cx="632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C7E1E2-D997-D6BE-B73D-A97C6E4A2138}"/>
              </a:ext>
            </a:extLst>
          </p:cNvPr>
          <p:cNvSpPr txBox="1"/>
          <p:nvPr/>
        </p:nvSpPr>
        <p:spPr>
          <a:xfrm>
            <a:off x="0" y="94065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047888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BD0C80-CBD2-D1D4-574D-00F1FD2708D5}"/>
              </a:ext>
            </a:extLst>
          </p:cNvPr>
          <p:cNvSpPr txBox="1"/>
          <p:nvPr/>
        </p:nvSpPr>
        <p:spPr>
          <a:xfrm>
            <a:off x="0" y="94065"/>
            <a:ext cx="25370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  <a:p>
            <a:endParaRPr lang="en-US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EDC8BCAB-E74D-50A9-1BB4-63065000C0F8}"/>
              </a:ext>
            </a:extLst>
          </p:cNvPr>
          <p:cNvGrpSpPr/>
          <p:nvPr/>
        </p:nvGrpSpPr>
        <p:grpSpPr>
          <a:xfrm>
            <a:off x="294985" y="584832"/>
            <a:ext cx="3166680" cy="2179326"/>
            <a:chOff x="6932860" y="479712"/>
            <a:chExt cx="7662727" cy="421679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F2569A4-1F08-1707-8FBB-BD653C4003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71000"/>
                      </a14:imgEffect>
                      <a14:imgEffect>
                        <a14:brightnessContrast bright="40000" contrast="56000"/>
                      </a14:imgEffect>
                    </a14:imgLayer>
                  </a14:imgProps>
                </a:ext>
              </a:extLst>
            </a:blip>
            <a:srcRect l="15287" t="38709" b="18835"/>
            <a:stretch/>
          </p:blipFill>
          <p:spPr>
            <a:xfrm>
              <a:off x="7919332" y="975268"/>
              <a:ext cx="3257491" cy="372124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FD90F7E-B22E-66E0-0566-435AF4AF4A03}"/>
                </a:ext>
              </a:extLst>
            </p:cNvPr>
            <p:cNvSpPr txBox="1"/>
            <p:nvPr/>
          </p:nvSpPr>
          <p:spPr>
            <a:xfrm>
              <a:off x="8249852" y="479712"/>
              <a:ext cx="6345735" cy="5955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WT+WT     WT+Xkr8KO   WT+XKr8KO</a:t>
              </a:r>
            </a:p>
            <a:p>
              <a:r>
                <a:rPr lang="en-US" sz="700" dirty="0"/>
                <a:t>                    Clone 1        Clone 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5C260B3-F74B-D557-FEEE-3FB55DD39A47}"/>
                </a:ext>
              </a:extLst>
            </p:cNvPr>
            <p:cNvSpPr txBox="1"/>
            <p:nvPr/>
          </p:nvSpPr>
          <p:spPr>
            <a:xfrm>
              <a:off x="6932860" y="3085965"/>
              <a:ext cx="1499576" cy="4168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200 bp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23E656D-E261-5FE4-3B70-8AE08AD75557}"/>
                </a:ext>
              </a:extLst>
            </p:cNvPr>
            <p:cNvSpPr txBox="1"/>
            <p:nvPr/>
          </p:nvSpPr>
          <p:spPr>
            <a:xfrm>
              <a:off x="6932860" y="2628506"/>
              <a:ext cx="1499576" cy="4168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00 b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F2F63DD-7744-39C5-F4E6-FAA8951C6261}"/>
                </a:ext>
              </a:extLst>
            </p:cNvPr>
            <p:cNvSpPr txBox="1"/>
            <p:nvPr/>
          </p:nvSpPr>
          <p:spPr>
            <a:xfrm>
              <a:off x="6932860" y="2147896"/>
              <a:ext cx="1239897" cy="4168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500 bp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1D089F40-1164-00C0-28B1-D2F8BC729ABF}"/>
              </a:ext>
            </a:extLst>
          </p:cNvPr>
          <p:cNvSpPr txBox="1"/>
          <p:nvPr/>
        </p:nvSpPr>
        <p:spPr>
          <a:xfrm>
            <a:off x="476533" y="2725882"/>
            <a:ext cx="1673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rveyor assa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CBD29C-6399-07FE-B296-D6DA9DF8EBE4}"/>
              </a:ext>
            </a:extLst>
          </p:cNvPr>
          <p:cNvSpPr txBox="1"/>
          <p:nvPr/>
        </p:nvSpPr>
        <p:spPr>
          <a:xfrm>
            <a:off x="181573" y="623715"/>
            <a:ext cx="127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E7E49E0-F326-CC83-17C5-5E03EC17C5C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529"/>
          <a:stretch/>
        </p:blipFill>
        <p:spPr>
          <a:xfrm>
            <a:off x="2827724" y="779366"/>
            <a:ext cx="3367359" cy="131908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6B397A8-27AB-A80B-B59B-0050939FA0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98783" y="375377"/>
            <a:ext cx="2584758" cy="3390059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060E33D8-E8CC-C9E8-C67D-441C3418245A}"/>
              </a:ext>
            </a:extLst>
          </p:cNvPr>
          <p:cNvSpPr txBox="1"/>
          <p:nvPr/>
        </p:nvSpPr>
        <p:spPr>
          <a:xfrm>
            <a:off x="2443067" y="566381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305FC41-C823-2CA3-7263-95875658CFD7}"/>
              </a:ext>
            </a:extLst>
          </p:cNvPr>
          <p:cNvSpPr txBox="1"/>
          <p:nvPr/>
        </p:nvSpPr>
        <p:spPr>
          <a:xfrm>
            <a:off x="6195083" y="556383"/>
            <a:ext cx="4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.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F8FB0ED-6349-65D0-1498-2F5500796536}"/>
              </a:ext>
            </a:extLst>
          </p:cNvPr>
          <p:cNvGrpSpPr/>
          <p:nvPr/>
        </p:nvGrpSpPr>
        <p:grpSpPr>
          <a:xfrm>
            <a:off x="8293587" y="3950794"/>
            <a:ext cx="3445026" cy="2916565"/>
            <a:chOff x="8437926" y="3432646"/>
            <a:chExt cx="3761257" cy="3343402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C27E12F3-DBD7-FCC7-B269-2EE2019E3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56581" b="6385"/>
            <a:stretch/>
          </p:blipFill>
          <p:spPr>
            <a:xfrm>
              <a:off x="8437926" y="3432646"/>
              <a:ext cx="3477244" cy="3127224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5CB0B7A-27EA-91AB-D2AC-F4DC5C3AA8B0}"/>
                </a:ext>
              </a:extLst>
            </p:cNvPr>
            <p:cNvSpPr txBox="1"/>
            <p:nvPr/>
          </p:nvSpPr>
          <p:spPr>
            <a:xfrm>
              <a:off x="11540216" y="5794936"/>
              <a:ext cx="6488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AF1046C-8DDD-69F3-F511-7BB40CCACF1E}"/>
                </a:ext>
              </a:extLst>
            </p:cNvPr>
            <p:cNvSpPr txBox="1"/>
            <p:nvPr/>
          </p:nvSpPr>
          <p:spPr>
            <a:xfrm>
              <a:off x="10791580" y="5384983"/>
              <a:ext cx="13861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TMEM16F KO clone 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CE9BDD8-3501-6842-DDDB-A20826B9CC38}"/>
                </a:ext>
              </a:extLst>
            </p:cNvPr>
            <p:cNvSpPr txBox="1"/>
            <p:nvPr/>
          </p:nvSpPr>
          <p:spPr>
            <a:xfrm>
              <a:off x="10802956" y="4960299"/>
              <a:ext cx="13861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TMEM16F KO clone 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D383799-8EEA-CCF2-8A23-93169AE20774}"/>
                </a:ext>
              </a:extLst>
            </p:cNvPr>
            <p:cNvSpPr txBox="1"/>
            <p:nvPr/>
          </p:nvSpPr>
          <p:spPr>
            <a:xfrm>
              <a:off x="11522966" y="4467122"/>
              <a:ext cx="6661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D083674-1CEE-A3EB-0AB3-0666D1128EAD}"/>
                </a:ext>
              </a:extLst>
            </p:cNvPr>
            <p:cNvSpPr txBox="1"/>
            <p:nvPr/>
          </p:nvSpPr>
          <p:spPr>
            <a:xfrm>
              <a:off x="10813043" y="4005457"/>
              <a:ext cx="13861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TMEM16F KO clone 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2A500FA-EA68-DBB1-E6C0-B811A2A02079}"/>
                </a:ext>
              </a:extLst>
            </p:cNvPr>
            <p:cNvSpPr txBox="1"/>
            <p:nvPr/>
          </p:nvSpPr>
          <p:spPr>
            <a:xfrm>
              <a:off x="10775678" y="3517929"/>
              <a:ext cx="13861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MEM16F KO clone 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BEB6312-538B-605E-6B89-7226A0F2637A}"/>
                </a:ext>
              </a:extLst>
            </p:cNvPr>
            <p:cNvSpPr txBox="1"/>
            <p:nvPr/>
          </p:nvSpPr>
          <p:spPr>
            <a:xfrm>
              <a:off x="9089864" y="5841823"/>
              <a:ext cx="116198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Normoxia 21% O</a:t>
              </a:r>
              <a:r>
                <a:rPr lang="en-US" sz="1100" baseline="-250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4D6CB6A-B4B1-22EC-8AE6-494960F4BE65}"/>
                </a:ext>
              </a:extLst>
            </p:cNvPr>
            <p:cNvSpPr txBox="1"/>
            <p:nvPr/>
          </p:nvSpPr>
          <p:spPr>
            <a:xfrm>
              <a:off x="9089864" y="4553270"/>
              <a:ext cx="100778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ypoxia 2% O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74ED65D0-610C-1B33-8702-8E130DE2AA11}"/>
                </a:ext>
              </a:extLst>
            </p:cNvPr>
            <p:cNvCxnSpPr/>
            <p:nvPr/>
          </p:nvCxnSpPr>
          <p:spPr>
            <a:xfrm flipV="1">
              <a:off x="9282787" y="3638174"/>
              <a:ext cx="0" cy="92123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1993F916-F8FE-A30E-4916-D1F5C2791BFB}"/>
                </a:ext>
              </a:extLst>
            </p:cNvPr>
            <p:cNvCxnSpPr/>
            <p:nvPr/>
          </p:nvCxnSpPr>
          <p:spPr>
            <a:xfrm flipV="1">
              <a:off x="9250982" y="5005798"/>
              <a:ext cx="0" cy="92123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1CF4D4A-BE4C-8536-9FC0-99DA836F067D}"/>
                </a:ext>
              </a:extLst>
            </p:cNvPr>
            <p:cNvSpPr txBox="1"/>
            <p:nvPr/>
          </p:nvSpPr>
          <p:spPr>
            <a:xfrm>
              <a:off x="10026594" y="6468271"/>
              <a:ext cx="14047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/>
                <a:t>Annexin V-IFTC</a:t>
              </a:r>
            </a:p>
          </p:txBody>
        </p:sp>
      </p:grpSp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522CD746-A426-3BD0-65DE-DE61897A20E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1573" y="4355754"/>
          <a:ext cx="4551800" cy="2179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6210229" imgH="2973188" progId="Prism10.Document">
                  <p:embed/>
                </p:oleObj>
              </mc:Choice>
              <mc:Fallback>
                <p:oleObj name="Prism 10" r:id="rId7" imgW="6210229" imgH="2973188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522CD746-A426-3BD0-65DE-DE61897A20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1573" y="4355754"/>
                        <a:ext cx="4551800" cy="2179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7DEF7F10-BD6F-4AB0-2325-D67E2ECB6D7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33373" y="4355754"/>
          <a:ext cx="3833891" cy="233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5230556" imgH="3183424" progId="Prism10.Document">
                  <p:embed/>
                </p:oleObj>
              </mc:Choice>
              <mc:Fallback>
                <p:oleObj name="Prism 10" r:id="rId9" imgW="5230556" imgH="3183424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7DEF7F10-BD6F-4AB0-2325-D67E2ECB6D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33373" y="4355754"/>
                        <a:ext cx="3833891" cy="233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A7DD5CFD-65D8-D5DE-6B5B-076775D91BCC}"/>
              </a:ext>
            </a:extLst>
          </p:cNvPr>
          <p:cNvSpPr txBox="1"/>
          <p:nvPr/>
        </p:nvSpPr>
        <p:spPr>
          <a:xfrm>
            <a:off x="187144" y="3947452"/>
            <a:ext cx="400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.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D911C5D-5E95-76EF-DE06-55F23F0F23BE}"/>
              </a:ext>
            </a:extLst>
          </p:cNvPr>
          <p:cNvSpPr txBox="1"/>
          <p:nvPr/>
        </p:nvSpPr>
        <p:spPr>
          <a:xfrm>
            <a:off x="4522078" y="4116785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F57636F-4A87-7AEE-BF4F-9260A6E73452}"/>
              </a:ext>
            </a:extLst>
          </p:cNvPr>
          <p:cNvSpPr txBox="1"/>
          <p:nvPr/>
        </p:nvSpPr>
        <p:spPr>
          <a:xfrm>
            <a:off x="8162745" y="3913585"/>
            <a:ext cx="346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.</a:t>
            </a:r>
          </a:p>
        </p:txBody>
      </p:sp>
    </p:spTree>
    <p:extLst>
      <p:ext uri="{BB962C8B-B14F-4D97-AF65-F5344CB8AC3E}">
        <p14:creationId xmlns:p14="http://schemas.microsoft.com/office/powerpoint/2010/main" val="3485440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74</Words>
  <Application>Microsoft Macintosh PowerPoint</Application>
  <PresentationFormat>Widescreen</PresentationFormat>
  <Paragraphs>2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viewer</dc:creator>
  <cp:lastModifiedBy>Reviewer</cp:lastModifiedBy>
  <cp:revision>3</cp:revision>
  <dcterms:created xsi:type="dcterms:W3CDTF">2025-04-17T22:07:01Z</dcterms:created>
  <dcterms:modified xsi:type="dcterms:W3CDTF">2025-05-15T19:09:10Z</dcterms:modified>
</cp:coreProperties>
</file>